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3" autoAdjust="0"/>
    <p:restoredTop sz="94660"/>
  </p:normalViewPr>
  <p:slideViewPr>
    <p:cSldViewPr snapToGrid="0">
      <p:cViewPr varScale="1">
        <p:scale>
          <a:sx n="76" d="100"/>
          <a:sy n="76" d="100"/>
        </p:scale>
        <p:origin x="84" y="4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3051F2-7E13-6E5E-CD1B-F7CCA0B138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31CA1EA-5225-D7A2-21C7-E0A1AFC7C0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F2C9AF-5859-6E98-1259-EB6494307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0430D5-2FDB-6A92-8CDD-496FD26D3F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23D2C8-36BE-67D9-74A1-48FFA6635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3136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CCAE5A-AE4D-E90D-C3E9-43CF68430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B621CAA-0581-6709-A400-43BEF57BE1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1D9C69-6547-8A88-2924-91B762B13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F96E2C-D1E7-8AA9-83AA-2503A9D78B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E468D8F-EA06-F58F-BA6F-E62465535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0547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AAB559C-03EC-3017-88BF-44251B9278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029140-3556-3381-C8AA-60AB687A0D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96E862-0027-E320-89DE-56EF6D794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FF145A-8260-E57C-5452-7D6E85FF2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59BE7D-7EAA-7990-AF01-98F3F4865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5086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C743DF-C3AC-173B-E04D-C6D70850A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6D70932-8C1E-289D-676B-55EFE43976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270C3C-E5C6-FD91-7B6D-12BAFD333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7CC999-FD0B-749C-5153-2F2FFD361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619996-F03A-5D91-C2F2-C94BDC593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290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44D836-1E50-8FAF-FAF0-553D0BB7CB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ABDF2F-08E8-AD43-C3F1-90A4AA283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5F128F-AFD8-0489-A08E-D77C53BB9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57E7BA-9BDD-9D48-CEDF-3E6501723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8B9C44-F851-DDE7-E073-070094771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330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EAFBF2-CB5F-6E57-0C0E-3D087EA06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8B5A4D-45A2-3263-BEB9-DC31967A4D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6FCEDF9-A540-585C-3712-AF67CF571E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4B798B-9D1C-CB64-73DA-FD21389C1C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67936A-77EF-84F9-1F6A-93F1E038F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8B23B9-62EE-0B82-FBAF-F9C5B55EC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650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DE112-2495-2BB1-1B31-A9000221F8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E6AC5C-6074-60C6-E8A9-1C73A3108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EBF719C-6849-63B7-BDDB-9D28F2FEAD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ACAB599-195D-E317-811F-88868FD5AD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48600B-1220-E1CC-E8F0-3E0C65EB18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9EC9DF4-7E78-3758-85B2-1F225AC70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4D005A0-C7B0-38D0-552A-4F8ABE200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E60C737-EC0A-05AB-4970-EFFD03765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85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0F6FF4-112C-3632-3B47-366A55ABD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7060C2-4D08-B205-8F7F-1A3625362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E15B676-15BA-FA8C-ECF0-E0DC137F8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BA1B4D7-4479-63C5-1CA0-31F14AE4D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0937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0CBC6DC-A00B-50CC-EAE8-D2C45B98A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43460F2-890D-BF3C-F9D0-30120FAA5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9CD29A7-665A-7E4B-539B-4F5F5792D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0921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A658A-E69C-8D9A-B221-D1466DC55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B0CB7C-43E3-023A-7DE0-3D0C20E626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3A3374-116B-4B5A-FC5D-282CB64C51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844EDF-B1F2-C57D-FE9D-5D3570719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D6B0F5-1356-4AFB-C58E-8FC91EC44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DC38D28-A7BC-8DFC-A986-5AFC5A732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94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2EAAEC-90E9-174D-7FA0-BC6D2BA0AB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5E0DC09-9217-9D59-6287-C70B782CAF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D56F2C-8423-7261-4D5A-4EB2B5F422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23B46DA-3825-D847-783A-6FABF26AF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B5DE85E-3916-0A02-C980-EDA7E7F77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E0CAA0C-1580-E68A-B07A-E7FEDA278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6515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2F2D635-B82A-3741-419D-D3F1B0E875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40BECEF-F487-53DB-1C9B-530B1965A6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4CEC78-59B6-FD06-E79E-8A71F3D91A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890BF-311F-447A-B6AA-CCD11DEB23BD}" type="datetimeFigureOut">
              <a:rPr lang="zh-CN" altLang="en-US" smtClean="0"/>
              <a:t>2025/4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9FED4F-6468-B91E-3533-F60EA69B25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14A38A-6D87-4F1F-4EA9-0B7F03D7D7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F1FE8-BF74-476A-9546-A8616742B2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2246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组合 9">
            <a:extLst>
              <a:ext uri="{FF2B5EF4-FFF2-40B4-BE49-F238E27FC236}">
                <a16:creationId xmlns:a16="http://schemas.microsoft.com/office/drawing/2014/main" id="{1170D592-67B2-444D-9A9D-57C15048D5B4}"/>
              </a:ext>
            </a:extLst>
          </p:cNvPr>
          <p:cNvGrpSpPr/>
          <p:nvPr/>
        </p:nvGrpSpPr>
        <p:grpSpPr>
          <a:xfrm>
            <a:off x="1563461" y="79023"/>
            <a:ext cx="7445249" cy="6598466"/>
            <a:chOff x="1563461" y="79023"/>
            <a:chExt cx="7445249" cy="6598466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66126413-7108-4FCA-872B-7EEA1D0B4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0899" r="25177" b="56049"/>
            <a:stretch/>
          </p:blipFill>
          <p:spPr>
            <a:xfrm>
              <a:off x="2460978" y="408844"/>
              <a:ext cx="3240000" cy="3097633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4E37818E-8949-4F90-B4D3-EE82C4516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482" t="46749" r="22320" b="3703"/>
            <a:stretch/>
          </p:blipFill>
          <p:spPr>
            <a:xfrm>
              <a:off x="5768710" y="409660"/>
              <a:ext cx="3240000" cy="3096000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34618DD3-0235-401C-913B-5C9B9BD8D010}"/>
                </a:ext>
              </a:extLst>
            </p:cNvPr>
            <p:cNvSpPr txBox="1"/>
            <p:nvPr/>
          </p:nvSpPr>
          <p:spPr>
            <a:xfrm>
              <a:off x="1603022" y="1667404"/>
              <a:ext cx="857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3W</a:t>
              </a:r>
              <a:endParaRPr lang="zh-CN" altLang="en-US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01703F3-6316-45AC-B439-00CEF6499834}"/>
                </a:ext>
              </a:extLst>
            </p:cNvPr>
            <p:cNvSpPr txBox="1"/>
            <p:nvPr/>
          </p:nvSpPr>
          <p:spPr>
            <a:xfrm>
              <a:off x="3787423" y="79023"/>
              <a:ext cx="104422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ON</a:t>
              </a:r>
              <a:endParaRPr lang="zh-CN" altLang="en-US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E8D18B8-E6B0-4E94-959D-5A6B7787412B}"/>
                </a:ext>
              </a:extLst>
            </p:cNvPr>
            <p:cNvSpPr txBox="1"/>
            <p:nvPr/>
          </p:nvSpPr>
          <p:spPr>
            <a:xfrm>
              <a:off x="6694311" y="79023"/>
              <a:ext cx="14619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OM/DSS</a:t>
              </a:r>
              <a:endParaRPr lang="zh-CN" altLang="en-US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F6FA800-8026-4672-B622-D11F5BC52B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305" t="10164" r="15583" b="45299"/>
            <a:stretch/>
          </p:blipFill>
          <p:spPr>
            <a:xfrm>
              <a:off x="2460978" y="3579856"/>
              <a:ext cx="3240000" cy="3097633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00D239F2-9A63-4ECC-8C79-D8310E6394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174" t="57638" r="17517" b="1136"/>
            <a:stretch/>
          </p:blipFill>
          <p:spPr>
            <a:xfrm>
              <a:off x="5768710" y="3579856"/>
              <a:ext cx="3240000" cy="3096000"/>
            </a:xfrm>
            <a:prstGeom prst="rect">
              <a:avLst/>
            </a:prstGeom>
          </p:spPr>
        </p:pic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B367961-3DB3-42CB-BBDF-3B7085D95F64}"/>
                </a:ext>
              </a:extLst>
            </p:cNvPr>
            <p:cNvSpPr txBox="1"/>
            <p:nvPr/>
          </p:nvSpPr>
          <p:spPr>
            <a:xfrm>
              <a:off x="1563461" y="4758524"/>
              <a:ext cx="8579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6W</a:t>
              </a:r>
              <a:endParaRPr lang="zh-CN" altLang="en-US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0C10AAEA-E4E1-D88C-8BBB-909DAF14C393}"/>
              </a:ext>
            </a:extLst>
          </p:cNvPr>
          <p:cNvSpPr txBox="1"/>
          <p:nvPr/>
        </p:nvSpPr>
        <p:spPr>
          <a:xfrm>
            <a:off x="9210191" y="2633134"/>
            <a:ext cx="2836695" cy="21253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800"/>
              </a:spcAft>
            </a:pPr>
            <a:r>
              <a:rPr lang="en-US" altLang="zh-CN" sz="1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gure </a:t>
            </a:r>
            <a:r>
              <a:rPr lang="en-US" altLang="zh-CN" sz="1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mages of colon tissues in the control and experimental groups of C57 mice after different AOM-DSS cycles</a:t>
            </a:r>
            <a:endParaRPr lang="zh-CN" altLang="zh-CN" sz="2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椭圆 12">
            <a:extLst>
              <a:ext uri="{FF2B5EF4-FFF2-40B4-BE49-F238E27FC236}">
                <a16:creationId xmlns:a16="http://schemas.microsoft.com/office/drawing/2014/main" id="{2133FA73-0935-75D0-39D6-B35CDF17AFF5}"/>
              </a:ext>
            </a:extLst>
          </p:cNvPr>
          <p:cNvSpPr/>
          <p:nvPr/>
        </p:nvSpPr>
        <p:spPr>
          <a:xfrm>
            <a:off x="5808277" y="930584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椭圆 13">
            <a:extLst>
              <a:ext uri="{FF2B5EF4-FFF2-40B4-BE49-F238E27FC236}">
                <a16:creationId xmlns:a16="http://schemas.microsoft.com/office/drawing/2014/main" id="{6AD61B33-9B0B-0319-32E7-45D9021E3F55}"/>
              </a:ext>
            </a:extLst>
          </p:cNvPr>
          <p:cNvSpPr/>
          <p:nvPr/>
        </p:nvSpPr>
        <p:spPr>
          <a:xfrm>
            <a:off x="7214943" y="1118513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椭圆 14">
            <a:extLst>
              <a:ext uri="{FF2B5EF4-FFF2-40B4-BE49-F238E27FC236}">
                <a16:creationId xmlns:a16="http://schemas.microsoft.com/office/drawing/2014/main" id="{EC4354A8-45F7-1B4E-D318-03140CDD6BAF}"/>
              </a:ext>
            </a:extLst>
          </p:cNvPr>
          <p:cNvSpPr/>
          <p:nvPr/>
        </p:nvSpPr>
        <p:spPr>
          <a:xfrm>
            <a:off x="8391865" y="1369366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椭圆 15">
            <a:extLst>
              <a:ext uri="{FF2B5EF4-FFF2-40B4-BE49-F238E27FC236}">
                <a16:creationId xmlns:a16="http://schemas.microsoft.com/office/drawing/2014/main" id="{97324A76-8C82-3756-E74E-7728AF97BBE0}"/>
              </a:ext>
            </a:extLst>
          </p:cNvPr>
          <p:cNvSpPr/>
          <p:nvPr/>
        </p:nvSpPr>
        <p:spPr>
          <a:xfrm>
            <a:off x="8301504" y="2201709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椭圆 16">
            <a:extLst>
              <a:ext uri="{FF2B5EF4-FFF2-40B4-BE49-F238E27FC236}">
                <a16:creationId xmlns:a16="http://schemas.microsoft.com/office/drawing/2014/main" id="{006DA89A-E23A-29DB-F2CC-9D4BA3278324}"/>
              </a:ext>
            </a:extLst>
          </p:cNvPr>
          <p:cNvSpPr/>
          <p:nvPr/>
        </p:nvSpPr>
        <p:spPr>
          <a:xfrm>
            <a:off x="5916381" y="5425710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椭圆 17">
            <a:extLst>
              <a:ext uri="{FF2B5EF4-FFF2-40B4-BE49-F238E27FC236}">
                <a16:creationId xmlns:a16="http://schemas.microsoft.com/office/drawing/2014/main" id="{5B2D0867-1A8F-CD69-4848-94362D8E8574}"/>
              </a:ext>
            </a:extLst>
          </p:cNvPr>
          <p:cNvSpPr/>
          <p:nvPr/>
        </p:nvSpPr>
        <p:spPr>
          <a:xfrm>
            <a:off x="6987898" y="4626150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椭圆 18">
            <a:extLst>
              <a:ext uri="{FF2B5EF4-FFF2-40B4-BE49-F238E27FC236}">
                <a16:creationId xmlns:a16="http://schemas.microsoft.com/office/drawing/2014/main" id="{B47DAB4A-428F-D7EB-BF1A-38E715453FA3}"/>
              </a:ext>
            </a:extLst>
          </p:cNvPr>
          <p:cNvSpPr/>
          <p:nvPr/>
        </p:nvSpPr>
        <p:spPr>
          <a:xfrm>
            <a:off x="6927220" y="5739487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椭圆 19">
            <a:extLst>
              <a:ext uri="{FF2B5EF4-FFF2-40B4-BE49-F238E27FC236}">
                <a16:creationId xmlns:a16="http://schemas.microsoft.com/office/drawing/2014/main" id="{F644561E-6D72-9023-129C-E3AB25FBA394}"/>
              </a:ext>
            </a:extLst>
          </p:cNvPr>
          <p:cNvSpPr/>
          <p:nvPr/>
        </p:nvSpPr>
        <p:spPr>
          <a:xfrm>
            <a:off x="8301504" y="4823880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椭圆 20">
            <a:extLst>
              <a:ext uri="{FF2B5EF4-FFF2-40B4-BE49-F238E27FC236}">
                <a16:creationId xmlns:a16="http://schemas.microsoft.com/office/drawing/2014/main" id="{6E8D9849-A4DE-F8C3-384C-9C1AB99885F3}"/>
              </a:ext>
            </a:extLst>
          </p:cNvPr>
          <p:cNvSpPr/>
          <p:nvPr/>
        </p:nvSpPr>
        <p:spPr>
          <a:xfrm>
            <a:off x="8373453" y="5558906"/>
            <a:ext cx="575446" cy="50170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765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huzheng Song</dc:creator>
  <cp:lastModifiedBy>Shuzheng Song</cp:lastModifiedBy>
  <cp:revision>2</cp:revision>
  <dcterms:created xsi:type="dcterms:W3CDTF">2025-04-11T01:46:23Z</dcterms:created>
  <dcterms:modified xsi:type="dcterms:W3CDTF">2025-04-11T07:55:42Z</dcterms:modified>
</cp:coreProperties>
</file>